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9081"/>
  </p:normalViewPr>
  <p:slideViewPr>
    <p:cSldViewPr snapToGrid="0" snapToObjects="1">
      <p:cViewPr varScale="1">
        <p:scale>
          <a:sx n="116" d="100"/>
          <a:sy n="116" d="100"/>
        </p:scale>
        <p:origin x="9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34A73-E603-AA49-B907-1D4494B241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5B8DFB-8963-8142-A9F5-DB1ABC95BB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B9C49-382B-EB4D-B7F8-7A928D72A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1278B-E278-6E47-A4B9-41D638413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78AFB2-7F50-8342-8DD0-E30C8F0B5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39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4BBAF-E0BE-3C4C-9F45-561EAD09E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63100E-ED57-154B-BC98-C662779D1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689418-B5C0-9249-9A6E-8666A18CD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019131-0D3E-594F-9641-181779708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EC79B9-AE6E-DD4F-AA9B-1D20E0577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36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55D35D-DA4D-5440-848F-C27FDF6177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A359E1-6E82-B448-8A2A-A2CE714F22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412A34-0EA3-B547-B96C-FE72FCE3F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2BE2B-368F-8040-A95C-AF25764FC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0DE4F-3EB0-A141-9002-0D7FC6965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3746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FACD4-78AB-BF46-A845-B4B5307F6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9E7790-210A-D549-89CD-866931D673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5C8F9E-26EB-A74F-BDE7-3EE96CDAC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ABE91A-31DD-0241-A2A8-CAF493FB9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A50D3F-0998-394E-90DF-0FCC917A5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296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1EE20-EB33-0D41-A308-546A6A79B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232CF9-CDD8-F642-96D4-0FFBCE726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7565-D983-FD4C-A7A0-E53923955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8C14A5-EE38-2342-A45E-2A686935E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C10D5-9428-7146-8B23-84A004AF7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0180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B34BC-04A4-0C49-B166-015B56A2E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FD7DE-EA21-AE4B-B367-644AD33C8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2F2054-B068-CB41-8635-6494B15DB6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9E4114-0747-EC4D-B938-529E2D76D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91B169-8BFE-0A49-A376-919A39E72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8CA0B3-B38B-654A-AED1-FDC275498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6869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A89E4-9D97-9542-9FB4-3A1172658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C489EA-15EA-5647-8542-C4911CB248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954B78-CB92-B14B-A496-5E9ABC680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450834-BD4F-D942-89D1-719CADE727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C3B7D6-657F-0B4D-8FC5-104C145E5A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7C548A-120D-EC47-88F3-ECD4606C7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DA7930-3D1A-454D-9C4B-5FE433D7B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7804A3-CE9B-8941-8931-A0152308A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945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5D809-EE33-234A-8A73-3E41CDF22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2A0496-8EF2-2A40-AC4C-7AC162209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CEA6AE-4FA8-9C47-AE6C-712BA98B0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C50C02-121D-024B-AE29-4A279F0BA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636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98741E-DAF1-EA42-8C91-2D08B67D4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21F306-EE00-AC45-87AF-D1A9A2FFC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965527-556F-D046-A71F-490FC0981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360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EBF81-CAFC-1E4C-B03B-7FE92EFB7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B5029F-DBF7-EA4A-873A-667CD1F83A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9FB00-A3F0-6440-8973-926BB70CFC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86B2C8-B123-2240-8B39-C1F9649D0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536A6A-AD16-9E47-BE6B-4DCF46C1A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4BDD8D-D99E-7F47-A770-341ABA3F5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0395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FD8341-3ACE-6F46-BD15-A99042E7D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5CF815-6C28-0A4B-BFAB-7C0013250F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C4E9D5-F731-7246-A338-8A901F8F77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F46AE9-21DC-4542-98E4-48097F2C7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08E7E4-357A-F04A-9819-4C0728900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BD3DCB-0DEC-F646-B56B-05E67914C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326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E6F87E-7F79-374E-9C4A-3F79F2E30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A12467-3ACD-B04F-A31D-1B15421CA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5C5443-8896-0347-8D7F-69B4421432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28CC2-88DB-4748-A5C2-269CE3A7AF62}" type="datetimeFigureOut">
              <a:rPr lang="en-GB" smtClean="0"/>
              <a:t>2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98C1B-B8AB-604A-AC48-8EB08D240B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4F5A5-C475-0C4A-80D0-7C0709F0B2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3BCCE-0356-3243-B6AE-4BEE5EE6EA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871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5">
            <a:extLst>
              <a:ext uri="{FF2B5EF4-FFF2-40B4-BE49-F238E27FC236}">
                <a16:creationId xmlns:a16="http://schemas.microsoft.com/office/drawing/2014/main" id="{02BC6997-D0C0-9249-8FE2-1924D4365592}"/>
              </a:ext>
            </a:extLst>
          </p:cNvPr>
          <p:cNvSpPr txBox="1"/>
          <p:nvPr/>
        </p:nvSpPr>
        <p:spPr>
          <a:xfrm>
            <a:off x="1701800" y="5117560"/>
            <a:ext cx="84970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/>
              <a:t>Suppl</a:t>
            </a:r>
            <a:r>
              <a:rPr lang="de-DE" sz="1400" b="1" dirty="0"/>
              <a:t>. Fig. S3.</a:t>
            </a:r>
            <a:r>
              <a:rPr lang="de-DE" sz="1400" dirty="0"/>
              <a:t> </a:t>
            </a:r>
            <a:r>
              <a:rPr lang="de-DE" sz="1400" dirty="0" err="1"/>
              <a:t>Immunofluorescence</a:t>
            </a:r>
            <a:r>
              <a:rPr lang="de-DE" sz="1400" dirty="0"/>
              <a:t> </a:t>
            </a:r>
            <a:r>
              <a:rPr lang="de-DE" sz="1400" dirty="0" err="1"/>
              <a:t>staining</a:t>
            </a:r>
            <a:r>
              <a:rPr lang="de-DE" sz="1400" dirty="0"/>
              <a:t> </a:t>
            </a:r>
            <a:r>
              <a:rPr lang="de-DE" sz="1400" dirty="0" err="1"/>
              <a:t>using</a:t>
            </a:r>
            <a:r>
              <a:rPr lang="de-DE" sz="1400" dirty="0"/>
              <a:t> a </a:t>
            </a:r>
            <a:r>
              <a:rPr lang="de-DE" sz="1400" dirty="0" err="1"/>
              <a:t>mouse</a:t>
            </a:r>
            <a:r>
              <a:rPr lang="de-DE" sz="1400" dirty="0"/>
              <a:t> </a:t>
            </a:r>
            <a:r>
              <a:rPr lang="de-DE" sz="1400" dirty="0" err="1"/>
              <a:t>monoclonal</a:t>
            </a:r>
            <a:r>
              <a:rPr lang="de-DE" sz="1400" dirty="0"/>
              <a:t> anti-</a:t>
            </a:r>
            <a:r>
              <a:rPr lang="de-DE" sz="1400" dirty="0" err="1"/>
              <a:t>taxol</a:t>
            </a:r>
            <a:r>
              <a:rPr lang="de-DE" sz="1400" dirty="0"/>
              <a:t> </a:t>
            </a:r>
            <a:r>
              <a:rPr lang="de-DE" sz="1400" dirty="0" err="1"/>
              <a:t>antibody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spinning</a:t>
            </a:r>
            <a:r>
              <a:rPr lang="de-DE" sz="1400" dirty="0"/>
              <a:t> </a:t>
            </a:r>
            <a:r>
              <a:rPr lang="de-DE" sz="1400" dirty="0" err="1"/>
              <a:t>disc</a:t>
            </a:r>
            <a:r>
              <a:rPr lang="de-DE" sz="1400" dirty="0"/>
              <a:t> </a:t>
            </a:r>
            <a:r>
              <a:rPr lang="de-DE" sz="1400" dirty="0" err="1"/>
              <a:t>confocal</a:t>
            </a:r>
            <a:r>
              <a:rPr lang="de-DE" sz="1400" dirty="0"/>
              <a:t> </a:t>
            </a:r>
            <a:r>
              <a:rPr lang="de-DE" sz="1400" dirty="0" err="1"/>
              <a:t>microscopy</a:t>
            </a:r>
            <a:r>
              <a:rPr lang="de-DE" sz="1400" dirty="0"/>
              <a:t> in </a:t>
            </a:r>
            <a:r>
              <a:rPr lang="de-DE" sz="1400" dirty="0" err="1"/>
              <a:t>living</a:t>
            </a:r>
            <a:r>
              <a:rPr lang="de-DE" sz="1400" dirty="0"/>
              <a:t> </a:t>
            </a:r>
            <a:r>
              <a:rPr lang="de-DE" sz="1400" dirty="0" err="1"/>
              <a:t>taxus</a:t>
            </a:r>
            <a:r>
              <a:rPr lang="de-DE" sz="1400" dirty="0"/>
              <a:t>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during</a:t>
            </a:r>
            <a:r>
              <a:rPr lang="de-DE" sz="1400" dirty="0"/>
              <a:t> </a:t>
            </a:r>
            <a:r>
              <a:rPr lang="de-DE" sz="1400" dirty="0" err="1"/>
              <a:t>growth</a:t>
            </a:r>
            <a:r>
              <a:rPr lang="de-DE" sz="1400" dirty="0"/>
              <a:t> </a:t>
            </a:r>
            <a:r>
              <a:rPr lang="de-DE" sz="1400" dirty="0" err="1"/>
              <a:t>phase</a:t>
            </a:r>
            <a:r>
              <a:rPr lang="de-DE" sz="1400" dirty="0"/>
              <a:t>. </a:t>
            </a:r>
            <a:r>
              <a:rPr lang="de-DE" sz="1400" dirty="0" err="1"/>
              <a:t>Representative</a:t>
            </a:r>
            <a:r>
              <a:rPr lang="de-DE" sz="1400" dirty="0"/>
              <a:t> </a:t>
            </a:r>
            <a:r>
              <a:rPr lang="de-DE" sz="1400" dirty="0" err="1"/>
              <a:t>section</a:t>
            </a:r>
            <a:r>
              <a:rPr lang="de-DE" sz="1400" dirty="0"/>
              <a:t> </a:t>
            </a:r>
            <a:r>
              <a:rPr lang="de-DE" sz="1400" dirty="0" err="1"/>
              <a:t>from</a:t>
            </a:r>
            <a:r>
              <a:rPr lang="de-DE" sz="1400" dirty="0"/>
              <a:t> a </a:t>
            </a:r>
            <a:r>
              <a:rPr lang="de-DE" sz="1400" dirty="0" err="1"/>
              <a:t>z-stack</a:t>
            </a:r>
            <a:r>
              <a:rPr lang="de-DE" sz="1400" dirty="0"/>
              <a:t>. The </a:t>
            </a:r>
            <a:r>
              <a:rPr lang="de-DE" sz="1400" dirty="0" err="1"/>
              <a:t>white</a:t>
            </a:r>
            <a:r>
              <a:rPr lang="de-DE" sz="1400" dirty="0"/>
              <a:t> </a:t>
            </a:r>
            <a:r>
              <a:rPr lang="de-DE" sz="1400" dirty="0" err="1"/>
              <a:t>arrow</a:t>
            </a:r>
            <a:r>
              <a:rPr lang="de-DE" sz="1400" dirty="0"/>
              <a:t> </a:t>
            </a:r>
            <a:r>
              <a:rPr lang="de-DE" sz="1400" dirty="0" err="1"/>
              <a:t>indicates</a:t>
            </a:r>
            <a:r>
              <a:rPr lang="de-DE" sz="1400" dirty="0"/>
              <a:t> a </a:t>
            </a:r>
            <a:r>
              <a:rPr lang="de-DE" sz="1400" dirty="0" err="1"/>
              <a:t>cell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fluorescence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some</a:t>
            </a:r>
            <a:r>
              <a:rPr lang="de-DE" sz="1400" dirty="0"/>
              <a:t> </a:t>
            </a:r>
            <a:r>
              <a:rPr lang="de-DE" sz="1400" dirty="0" err="1"/>
              <a:t>part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surrounding</a:t>
            </a:r>
            <a:r>
              <a:rPr lang="de-DE" sz="1400" dirty="0"/>
              <a:t>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that</a:t>
            </a:r>
            <a:r>
              <a:rPr lang="de-DE" sz="1400" dirty="0"/>
              <a:t> </a:t>
            </a:r>
            <a:r>
              <a:rPr lang="de-DE" sz="1400" dirty="0" err="1"/>
              <a:t>show</a:t>
            </a:r>
            <a:r>
              <a:rPr lang="de-DE" sz="1400" dirty="0"/>
              <a:t> </a:t>
            </a:r>
            <a:r>
              <a:rPr lang="de-DE" sz="1400" dirty="0" err="1"/>
              <a:t>autofluorescence</a:t>
            </a:r>
            <a:r>
              <a:rPr lang="de-DE" sz="1400" dirty="0"/>
              <a:t>.</a:t>
            </a:r>
            <a:endParaRPr lang="en-GB" sz="14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8BF713F-3599-BA47-8CFA-0E499DFB53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8000" y="1126490"/>
            <a:ext cx="3048000" cy="3162300"/>
          </a:xfrm>
          <a:prstGeom prst="rect">
            <a:avLst/>
          </a:prstGeom>
        </p:spPr>
      </p:pic>
      <p:sp>
        <p:nvSpPr>
          <p:cNvPr id="7" name="Textfeld 23">
            <a:extLst>
              <a:ext uri="{FF2B5EF4-FFF2-40B4-BE49-F238E27FC236}">
                <a16:creationId xmlns:a16="http://schemas.microsoft.com/office/drawing/2014/main" id="{6BFE5084-496E-6949-B5A6-161A81BDA07C}"/>
              </a:ext>
            </a:extLst>
          </p:cNvPr>
          <p:cNvSpPr txBox="1"/>
          <p:nvPr/>
        </p:nvSpPr>
        <p:spPr>
          <a:xfrm>
            <a:off x="6583413" y="383037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10 µm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Rechteck 22">
            <a:extLst>
              <a:ext uri="{FF2B5EF4-FFF2-40B4-BE49-F238E27FC236}">
                <a16:creationId xmlns:a16="http://schemas.microsoft.com/office/drawing/2014/main" id="{11EA1E8C-D02C-BB4C-ABF1-2EF0FF25F9C7}"/>
              </a:ext>
            </a:extLst>
          </p:cNvPr>
          <p:cNvSpPr/>
          <p:nvPr/>
        </p:nvSpPr>
        <p:spPr>
          <a:xfrm>
            <a:off x="6787471" y="4175670"/>
            <a:ext cx="374469" cy="4571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713AABC-1E14-EE49-B9D2-B4AD4A2383AD}"/>
              </a:ext>
            </a:extLst>
          </p:cNvPr>
          <p:cNvCxnSpPr/>
          <p:nvPr/>
        </p:nvCxnSpPr>
        <p:spPr>
          <a:xfrm>
            <a:off x="5842000" y="1955260"/>
            <a:ext cx="0" cy="26156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320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5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raorane@gmail.com</dc:creator>
  <cp:lastModifiedBy>manishraorane@gmail.com</cp:lastModifiedBy>
  <cp:revision>5</cp:revision>
  <dcterms:created xsi:type="dcterms:W3CDTF">2022-06-26T11:22:21Z</dcterms:created>
  <dcterms:modified xsi:type="dcterms:W3CDTF">2022-06-26T21:24:20Z</dcterms:modified>
</cp:coreProperties>
</file>